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B56BDE5-DC8E-9D0E-01D6-32CF1CA539A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7BF7325F-70AE-AFA8-82CC-B5911F4677F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965E924-198F-D549-927E-4A1FE4EAB8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DABD4-E303-4A94-B1F0-9370CA1D84B8}" type="datetimeFigureOut">
              <a:rPr lang="it-IT" smtClean="0"/>
              <a:t>06/08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F863907-3D78-95D7-AB3B-AD7E6774EB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1917251-27E8-F1EE-C933-074B67A260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38188-BF92-4FF0-85EF-1C1F79644FD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944201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02C6492-6635-AFD2-848B-D453BD3968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050A9126-D676-C62D-1F50-51D7B9F79C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D4F3AC1-BE2B-FF4C-C789-8F33BD881D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DABD4-E303-4A94-B1F0-9370CA1D84B8}" type="datetimeFigureOut">
              <a:rPr lang="it-IT" smtClean="0"/>
              <a:t>06/08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514B040-7CC6-ADD0-019F-48CF947A39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1B96721-CB50-F0D7-B0A7-18209EA53B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38188-BF92-4FF0-85EF-1C1F79644FD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801716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400641EE-70F2-EED5-8ABA-F7DAA6D97DA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C4934B1E-D9AF-8CB3-E6B7-30B02D55C5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FE208F7-6542-BB9D-E424-2A87372D05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DABD4-E303-4A94-B1F0-9370CA1D84B8}" type="datetimeFigureOut">
              <a:rPr lang="it-IT" smtClean="0"/>
              <a:t>06/08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F78591B-C30E-CEB1-A6B8-96F91D6796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1B4ACA6-645E-9879-74FE-CA2CE17865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38188-BF92-4FF0-85EF-1C1F79644FD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896589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9430F3E-26E5-DCB3-E0F0-B2BDA87106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C0AB1197-348C-302A-D0A8-74E7E2FB0C8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291D16B-DFB8-F0DD-317A-28DF33DB3F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DABD4-E303-4A94-B1F0-9370CA1D84B8}" type="datetimeFigureOut">
              <a:rPr lang="it-IT" smtClean="0"/>
              <a:t>06/08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AC381AD-3262-FCEE-6E37-3EC9A007D0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865E5ED-95C7-A639-1046-8CAE8413CE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38188-BF92-4FF0-85EF-1C1F79644FD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888706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A0F01B1-D83E-6FE7-FF6C-0FE6962EB7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F3D015A-5FD7-AB60-5359-807369C2F6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3C7A19C-17CE-3E02-99EC-CCE7B751BD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DABD4-E303-4A94-B1F0-9370CA1D84B8}" type="datetimeFigureOut">
              <a:rPr lang="it-IT" smtClean="0"/>
              <a:t>06/08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3A57150-1F96-39AC-419A-FC562AE522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7797686-C246-5664-7E33-4D9CFD35E0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38188-BF92-4FF0-85EF-1C1F79644FD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211344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A907186-B5A8-A8A9-AF05-0F1810582A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31C7BEE0-25D0-393A-319C-87E2869D98A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608810A1-D9FA-B21F-2181-C8A25D5389D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37158739-874E-7D87-460B-5CBE4DE655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DABD4-E303-4A94-B1F0-9370CA1D84B8}" type="datetimeFigureOut">
              <a:rPr lang="it-IT" smtClean="0"/>
              <a:t>06/08/20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7B2BC283-32C0-C139-E303-4EB8DE6E2B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D85A8E57-165B-D990-20BC-8CC466B0FE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38188-BF92-4FF0-85EF-1C1F79644FD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701149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5725623-5DFB-4CD6-F3CD-DA8CF3EBED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23FD4D73-0A80-504A-DB4C-D830E73AE6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4281E4E6-FD3A-4B73-0BFB-D6FA2295170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33701345-51C8-F374-C8C9-A3226A78D92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76FE7C49-2E86-E32A-893C-37A41C4D5C8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607F66CD-AB7C-66D9-BFB1-FED62AA965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DABD4-E303-4A94-B1F0-9370CA1D84B8}" type="datetimeFigureOut">
              <a:rPr lang="it-IT" smtClean="0"/>
              <a:t>06/08/2022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36A42860-3E76-9255-5703-4F86EFA798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8DFBB4D4-D8F0-EBC6-8999-F1E2E6CD7C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38188-BF92-4FF0-85EF-1C1F79644FD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818813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D49E936-735D-A83D-F3DC-4B4E6530F6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50A1E45F-9AB0-8D12-F629-E66365B021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DABD4-E303-4A94-B1F0-9370CA1D84B8}" type="datetimeFigureOut">
              <a:rPr lang="it-IT" smtClean="0"/>
              <a:t>06/08/2022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3610AE05-64A9-02F3-6958-0CD6D6B0FD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4C884B2F-B63E-25EF-C191-33A0EAD234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38188-BF92-4FF0-85EF-1C1F79644FD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680404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F50C48B5-43C5-7C7F-CBFF-E10E5A3C0C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DABD4-E303-4A94-B1F0-9370CA1D84B8}" type="datetimeFigureOut">
              <a:rPr lang="it-IT" smtClean="0"/>
              <a:t>06/08/2022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A13F1423-9C36-DAFD-1661-9349C3FE6F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E7A2779A-9DC5-9CD1-71DB-D1CD651D57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38188-BF92-4FF0-85EF-1C1F79644FD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316371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3D108F5-3FE2-861D-0B8E-961F62D247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587E3159-3D95-DF73-75CB-28A71224980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35D84FC3-FCD8-5E88-0256-1509B81778F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5A4CAEAF-17E6-4115-B66A-AE14520382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DABD4-E303-4A94-B1F0-9370CA1D84B8}" type="datetimeFigureOut">
              <a:rPr lang="it-IT" smtClean="0"/>
              <a:t>06/08/20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EB5B584-A629-06D3-7836-877743F004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5B3FBA57-1879-9308-E2CC-E0609922B0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38188-BF92-4FF0-85EF-1C1F79644FD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180618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AEE1530-4513-1B7E-1890-5DEC763809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87E53B30-D17D-C810-4F0E-5FFAF26F4BC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89DC949C-DD88-4F2F-300F-46352A7A64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466CCD5E-6E36-41DB-1073-B2631560BB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DABD4-E303-4A94-B1F0-9370CA1D84B8}" type="datetimeFigureOut">
              <a:rPr lang="it-IT" smtClean="0"/>
              <a:t>06/08/20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C7D941E7-A6CC-BFE6-671E-73F4BC417F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6EF8F4A6-0C74-9744-A68C-C8C4068AC9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38188-BF92-4FF0-85EF-1C1F79644FD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986156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24F4859C-AEDA-3645-B556-57EBDA2E58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5565CEDB-E2BF-9A24-40C5-02041D1D7A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EA68B92-3DB3-B395-8E4D-6E110D6A969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CDABD4-E303-4A94-B1F0-9370CA1D84B8}" type="datetimeFigureOut">
              <a:rPr lang="it-IT" smtClean="0"/>
              <a:t>06/08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287B520-4ABF-B4FD-27AE-AEA944E6F95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02BD5D7-B9AF-1479-42AC-36E1482B2A1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038188-BF92-4FF0-85EF-1C1F79644FD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298457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tangolo 3">
            <a:extLst>
              <a:ext uri="{FF2B5EF4-FFF2-40B4-BE49-F238E27FC236}">
                <a16:creationId xmlns:a16="http://schemas.microsoft.com/office/drawing/2014/main" id="{6FFAF206-35C1-2A1E-B009-80FAC7BC15E1}"/>
              </a:ext>
            </a:extLst>
          </p:cNvPr>
          <p:cNvSpPr/>
          <p:nvPr/>
        </p:nvSpPr>
        <p:spPr>
          <a:xfrm>
            <a:off x="3915053" y="230821"/>
            <a:ext cx="2041864" cy="1171852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omen </a:t>
            </a:r>
            <a:r>
              <a:rPr lang="it-IT" sz="14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itially</a:t>
            </a:r>
            <a:endParaRPr lang="it-IT" sz="14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it-IT" sz="14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cluded</a:t>
            </a:r>
            <a:r>
              <a:rPr lang="it-IT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in the study</a:t>
            </a:r>
          </a:p>
          <a:p>
            <a:pPr algn="ctr"/>
            <a:r>
              <a:rPr lang="it-IT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n = 1020)</a:t>
            </a:r>
          </a:p>
        </p:txBody>
      </p:sp>
      <p:sp>
        <p:nvSpPr>
          <p:cNvPr id="6" name="Rettangolo 5">
            <a:extLst>
              <a:ext uri="{FF2B5EF4-FFF2-40B4-BE49-F238E27FC236}">
                <a16:creationId xmlns:a16="http://schemas.microsoft.com/office/drawing/2014/main" id="{EC46B243-E769-3AF0-0EFA-57B6E352D441}"/>
              </a:ext>
            </a:extLst>
          </p:cNvPr>
          <p:cNvSpPr/>
          <p:nvPr/>
        </p:nvSpPr>
        <p:spPr>
          <a:xfrm>
            <a:off x="3915053" y="5390227"/>
            <a:ext cx="2041864" cy="1171852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omen </a:t>
            </a:r>
            <a:r>
              <a:rPr lang="it-IT" sz="14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nally</a:t>
            </a:r>
            <a:endParaRPr lang="it-IT" sz="14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it-IT" sz="14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cluded</a:t>
            </a:r>
            <a:r>
              <a:rPr lang="it-IT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in the study</a:t>
            </a:r>
          </a:p>
          <a:p>
            <a:pPr algn="ctr"/>
            <a:r>
              <a:rPr lang="it-IT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n = 843)</a:t>
            </a:r>
          </a:p>
        </p:txBody>
      </p:sp>
      <p:cxnSp>
        <p:nvCxnSpPr>
          <p:cNvPr id="8" name="Connettore 2 7">
            <a:extLst>
              <a:ext uri="{FF2B5EF4-FFF2-40B4-BE49-F238E27FC236}">
                <a16:creationId xmlns:a16="http://schemas.microsoft.com/office/drawing/2014/main" id="{5F8CF1C2-1D30-22D9-09E7-C61E4DA39D78}"/>
              </a:ext>
            </a:extLst>
          </p:cNvPr>
          <p:cNvCxnSpPr>
            <a:cxnSpLocks/>
          </p:cNvCxnSpPr>
          <p:nvPr/>
        </p:nvCxnSpPr>
        <p:spPr>
          <a:xfrm>
            <a:off x="4935985" y="1589103"/>
            <a:ext cx="0" cy="3586579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Rettangolo 9">
            <a:extLst>
              <a:ext uri="{FF2B5EF4-FFF2-40B4-BE49-F238E27FC236}">
                <a16:creationId xmlns:a16="http://schemas.microsoft.com/office/drawing/2014/main" id="{5D07FD44-8AC0-02E6-7387-4F2098923C8F}"/>
              </a:ext>
            </a:extLst>
          </p:cNvPr>
          <p:cNvSpPr/>
          <p:nvPr/>
        </p:nvSpPr>
        <p:spPr>
          <a:xfrm>
            <a:off x="6232125" y="1651247"/>
            <a:ext cx="3062795" cy="1349406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omen </a:t>
            </a:r>
            <a:r>
              <a:rPr lang="it-IT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cluded</a:t>
            </a:r>
            <a:endParaRPr lang="it-IT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it-IT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or incomplete </a:t>
            </a:r>
            <a:r>
              <a:rPr lang="it-IT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ocumentation</a:t>
            </a:r>
            <a:r>
              <a:rPr lang="it-IT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it-IT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ir</a:t>
            </a:r>
            <a:endParaRPr lang="it-IT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it-IT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vious</a:t>
            </a:r>
            <a:r>
              <a:rPr lang="it-IT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gnancy</a:t>
            </a:r>
            <a:r>
              <a:rPr lang="it-IT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osses</a:t>
            </a:r>
            <a:endParaRPr lang="it-IT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it-IT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n = 127)</a:t>
            </a:r>
          </a:p>
          <a:p>
            <a:pPr algn="ctr"/>
            <a:r>
              <a:rPr lang="it-IT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12.45%)</a:t>
            </a:r>
          </a:p>
        </p:txBody>
      </p:sp>
      <p:cxnSp>
        <p:nvCxnSpPr>
          <p:cNvPr id="13" name="Connettore 2 12">
            <a:extLst>
              <a:ext uri="{FF2B5EF4-FFF2-40B4-BE49-F238E27FC236}">
                <a16:creationId xmlns:a16="http://schemas.microsoft.com/office/drawing/2014/main" id="{7E11A855-2B17-74FD-DA14-1EA488240B00}"/>
              </a:ext>
            </a:extLst>
          </p:cNvPr>
          <p:cNvCxnSpPr/>
          <p:nvPr/>
        </p:nvCxnSpPr>
        <p:spPr>
          <a:xfrm>
            <a:off x="4935985" y="2325950"/>
            <a:ext cx="1160015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Rettangolo 13">
            <a:extLst>
              <a:ext uri="{FF2B5EF4-FFF2-40B4-BE49-F238E27FC236}">
                <a16:creationId xmlns:a16="http://schemas.microsoft.com/office/drawing/2014/main" id="{52005C9A-9A7B-4589-8CC3-A1CC3CC49DD5}"/>
              </a:ext>
            </a:extLst>
          </p:cNvPr>
          <p:cNvSpPr/>
          <p:nvPr/>
        </p:nvSpPr>
        <p:spPr>
          <a:xfrm>
            <a:off x="6232125" y="3429000"/>
            <a:ext cx="3062795" cy="1349406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omen </a:t>
            </a:r>
            <a:r>
              <a:rPr lang="it-IT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cluded</a:t>
            </a:r>
            <a:endParaRPr lang="it-IT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it-IT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or incomplete data of the</a:t>
            </a:r>
          </a:p>
          <a:p>
            <a:pPr algn="ctr"/>
            <a:r>
              <a:rPr lang="it-IT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iagnostic</a:t>
            </a:r>
            <a:r>
              <a:rPr lang="it-IT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orkup</a:t>
            </a:r>
            <a:endParaRPr lang="it-IT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it-IT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n = 50)</a:t>
            </a:r>
          </a:p>
          <a:p>
            <a:pPr algn="ctr"/>
            <a:r>
              <a:rPr lang="it-IT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4.90%)</a:t>
            </a:r>
          </a:p>
        </p:txBody>
      </p:sp>
      <p:cxnSp>
        <p:nvCxnSpPr>
          <p:cNvPr id="15" name="Connettore 2 14">
            <a:extLst>
              <a:ext uri="{FF2B5EF4-FFF2-40B4-BE49-F238E27FC236}">
                <a16:creationId xmlns:a16="http://schemas.microsoft.com/office/drawing/2014/main" id="{902DB131-AC4B-F35C-30B5-724B8B8EE4E3}"/>
              </a:ext>
            </a:extLst>
          </p:cNvPr>
          <p:cNvCxnSpPr/>
          <p:nvPr/>
        </p:nvCxnSpPr>
        <p:spPr>
          <a:xfrm>
            <a:off x="4935984" y="4173985"/>
            <a:ext cx="1160015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5154089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7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carlo ticconi</dc:creator>
  <cp:lastModifiedBy>carlo ticconi</cp:lastModifiedBy>
  <cp:revision>2</cp:revision>
  <dcterms:created xsi:type="dcterms:W3CDTF">2022-08-06T15:17:51Z</dcterms:created>
  <dcterms:modified xsi:type="dcterms:W3CDTF">2022-08-06T15:20:23Z</dcterms:modified>
</cp:coreProperties>
</file>